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media/image1.png" ContentType="image/png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199313" cy="899953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95A850-2BE8-49B5-8A23-026C44C66A9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39640" y="799920"/>
            <a:ext cx="6121440" cy="1500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4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39640" y="2600280"/>
            <a:ext cx="612144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39640" y="5421240"/>
            <a:ext cx="612144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DE5C39-C3F8-4AA9-B775-3102936F4F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39640" y="799920"/>
            <a:ext cx="6121440" cy="1500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4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39640" y="2600280"/>
            <a:ext cx="298692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676320" y="2600280"/>
            <a:ext cx="298692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39640" y="5421240"/>
            <a:ext cx="298692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676320" y="5421240"/>
            <a:ext cx="298692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C046E0-2471-45BF-9D28-6A1C38E8DAC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39640" y="799920"/>
            <a:ext cx="6121440" cy="1500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4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39640" y="2600280"/>
            <a:ext cx="197100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609640" y="2600280"/>
            <a:ext cx="197100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679640" y="2600280"/>
            <a:ext cx="197100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39640" y="5421240"/>
            <a:ext cx="197100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609640" y="5421240"/>
            <a:ext cx="197100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679640" y="5421240"/>
            <a:ext cx="197100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BC82A0-8B9F-40ED-9959-0A626571078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39640" y="799920"/>
            <a:ext cx="6121440" cy="1500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4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39640" y="2600280"/>
            <a:ext cx="6121440" cy="5400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25"/>
              </a:spcBef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93CDDC-F04D-4276-A47F-CDC7A7ACF0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39640" y="799920"/>
            <a:ext cx="6121440" cy="1500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4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39640" y="2600280"/>
            <a:ext cx="6121440" cy="54007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A6A58F-0F7A-4C93-B1F3-35EA7D308A0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39640" y="799920"/>
            <a:ext cx="6121440" cy="1500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4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39640" y="2600280"/>
            <a:ext cx="2986920" cy="54007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676320" y="2600280"/>
            <a:ext cx="2986920" cy="54007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845662-71F2-41F5-8E6D-8A360693028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39640" y="799920"/>
            <a:ext cx="6121440" cy="1500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4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F38970-5976-49BA-A9BB-691678BC3DE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39640" y="799920"/>
            <a:ext cx="6121440" cy="6954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25"/>
              </a:spcBef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557E11-F39D-40A6-BA26-532D44CF296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39640" y="799920"/>
            <a:ext cx="6121440" cy="1500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4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39640" y="2600280"/>
            <a:ext cx="298692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676320" y="2600280"/>
            <a:ext cx="2986920" cy="54007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39640" y="5421240"/>
            <a:ext cx="298692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A784B7-A2DF-4C52-845C-C882EEB894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39640" y="799920"/>
            <a:ext cx="6121440" cy="1500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4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39640" y="2600280"/>
            <a:ext cx="2986920" cy="54007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676320" y="2600280"/>
            <a:ext cx="298692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676320" y="5421240"/>
            <a:ext cx="298692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0BB884-9429-4F53-8D70-39D52BE53B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39640" y="799920"/>
            <a:ext cx="6121440" cy="1500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4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39640" y="2600280"/>
            <a:ext cx="298692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676320" y="2600280"/>
            <a:ext cx="298692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39640" y="5421240"/>
            <a:ext cx="6121440" cy="25758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530804-F3A3-437D-933E-7C6F39BD4C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39640" y="799920"/>
            <a:ext cx="6121440" cy="1500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en-US" sz="45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39640" y="2600280"/>
            <a:ext cx="6121440" cy="54007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rmAutofit/>
          </a:bodyPr>
          <a:p>
            <a:pPr marL="347760" indent="-347760">
              <a:spcBef>
                <a:spcPts val="825"/>
              </a:spcBef>
              <a:buClr>
                <a:srgbClr val="000000"/>
              </a:buClr>
              <a:buFont typeface="Times New Roman"/>
              <a:buChar char="•"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  <a:p>
            <a:pPr lvl="1" marL="752400" indent="-288720">
              <a:spcBef>
                <a:spcPts val="825"/>
              </a:spcBef>
              <a:buClr>
                <a:srgbClr val="000000"/>
              </a:buClr>
              <a:buFont typeface="Times New Roman"/>
              <a:buChar char="–"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  <a:p>
            <a:pPr lvl="2" marL="1157400" indent="-231840">
              <a:spcBef>
                <a:spcPts val="825"/>
              </a:spcBef>
              <a:buClr>
                <a:srgbClr val="000000"/>
              </a:buClr>
              <a:buFont typeface="Times New Roman"/>
              <a:buChar char="•"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  <a:p>
            <a:pPr lvl="3" marL="1620720" indent="-231480">
              <a:spcBef>
                <a:spcPts val="825"/>
              </a:spcBef>
              <a:buClr>
                <a:srgbClr val="000000"/>
              </a:buClr>
              <a:buFont typeface="Times New Roman"/>
              <a:buChar char="–"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  <a:p>
            <a:pPr lvl="4" marL="2082960" indent="-230400">
              <a:spcBef>
                <a:spcPts val="825"/>
              </a:spcBef>
              <a:buClr>
                <a:srgbClr val="000000"/>
              </a:buClr>
              <a:buFont typeface="Times New Roman"/>
              <a:buChar char="»"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  <a:p>
            <a:pPr lvl="5" marL="2082960" indent="-230400">
              <a:spcBef>
                <a:spcPts val="825"/>
              </a:spcBef>
              <a:buClr>
                <a:srgbClr val="000000"/>
              </a:buClr>
              <a:buFont typeface="Times New Roman"/>
              <a:buChar char="»"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  <a:p>
            <a:pPr lvl="6" marL="2082960" indent="-230400">
              <a:spcBef>
                <a:spcPts val="825"/>
              </a:spcBef>
              <a:buClr>
                <a:srgbClr val="000000"/>
              </a:buClr>
              <a:buFont typeface="Times New Roman"/>
              <a:buChar char="»"/>
              <a:tabLst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39280" y="8200800"/>
            <a:ext cx="1500120" cy="600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Autofit/>
          </a:bodyPr>
          <a:lstStyle>
            <a:lvl1pPr indent="0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  <a:defRPr b="0" lang="de-DE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460600" y="8200800"/>
            <a:ext cx="2279520" cy="600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Autofit/>
          </a:bodyPr>
          <a:lstStyle>
            <a:lvl1pPr indent="0" algn="ctr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  <a:defRPr b="0" lang="de-DE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160600" y="8200800"/>
            <a:ext cx="1500120" cy="600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440" bIns="46440" anchor="t">
            <a:noAutofit/>
          </a:bodyPr>
          <a:lstStyle>
            <a:lvl1pPr indent="0" algn="r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  <a:defRPr b="0" lang="de-DE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fld id="{D110C36B-0CA5-4D21-B6AF-07A9DE25581D}" type="slidenum">
              <a:rPr b="0" lang="de-DE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png"/><Relationship Id="rId3" Type="http://schemas.openxmlformats.org/officeDocument/2006/relationships/package" Target="../embeddings/oleObject2.xlsx"/><Relationship Id="rId4" Type="http://schemas.openxmlformats.org/officeDocument/2006/relationships/image" Target="../media/image2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 rot="16200000">
            <a:off x="-446040" y="948240"/>
            <a:ext cx="1929240" cy="82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2520" rIns="92520" tIns="46440" bIns="4644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1" lang="de-DE" sz="3000" spc="-1" strike="noStrike">
                <a:solidFill>
                  <a:srgbClr val="000000"/>
                </a:solidFill>
                <a:latin typeface="Arial"/>
              </a:rPr>
              <a:t>TPI</a:t>
            </a: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(µM / mg protein)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1368360" y="420840"/>
          <a:ext cx="5432400" cy="227952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3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368360" y="420840"/>
                    <a:ext cx="5432400" cy="2279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4" name=""/>
          <p:cNvSpPr/>
          <p:nvPr/>
        </p:nvSpPr>
        <p:spPr>
          <a:xfrm rot="16200000">
            <a:off x="-817560" y="3739320"/>
            <a:ext cx="2685240" cy="82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2520" rIns="92520" tIns="46440" bIns="4644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1" lang="de-DE" sz="3000" spc="-1" strike="noStrike">
                <a:solidFill>
                  <a:srgbClr val="000000"/>
                </a:solidFill>
                <a:latin typeface="Arial"/>
              </a:rPr>
              <a:t>Emission</a:t>
            </a: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(peak area relative to IS)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45" name=""/>
          <p:cNvGraphicFramePr/>
          <p:nvPr/>
        </p:nvGraphicFramePr>
        <p:xfrm>
          <a:off x="1368360" y="2916360"/>
          <a:ext cx="5432400" cy="265572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46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368360" y="2916360"/>
                    <a:ext cx="5432400" cy="2655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7" name=""/>
          <p:cNvSpPr/>
          <p:nvPr/>
        </p:nvSpPr>
        <p:spPr>
          <a:xfrm>
            <a:off x="936720" y="252360"/>
            <a:ext cx="502920" cy="36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2520" rIns="92520" tIns="46440" bIns="46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1127520" y="2449440"/>
            <a:ext cx="312120" cy="36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2520" rIns="92520" tIns="46440" bIns="46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936720" y="2773440"/>
            <a:ext cx="502920" cy="36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2520" rIns="92520" tIns="46440" bIns="46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1092600" y="4932360"/>
            <a:ext cx="312120" cy="36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2520" rIns="92520" tIns="46440" bIns="46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1404360" y="351000"/>
            <a:ext cx="461520" cy="550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2520" rIns="92520" tIns="46440" bIns="46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1" lang="en-US" sz="3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1404360" y="2835360"/>
            <a:ext cx="461520" cy="550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2520" rIns="92520" tIns="46440" bIns="46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1" lang="en-US" sz="3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1387440" y="5156280"/>
            <a:ext cx="43056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108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1819440" y="5156280"/>
            <a:ext cx="43056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145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2286000" y="5157720"/>
            <a:ext cx="40752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1693440" y="5508720"/>
            <a:ext cx="756720" cy="45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1" lang="de-DE" sz="2700" spc="-1" strike="noStrike">
                <a:solidFill>
                  <a:srgbClr val="000000"/>
                </a:solidFill>
                <a:latin typeface="Arial"/>
              </a:rPr>
              <a:t>Con</a:t>
            </a: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5583960" y="5519880"/>
            <a:ext cx="1005120" cy="45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1" lang="de-DE" sz="2700" spc="-1" strike="noStrike">
                <a:solidFill>
                  <a:srgbClr val="000000"/>
                </a:solidFill>
                <a:latin typeface="Arial"/>
              </a:rPr>
              <a:t>MeJA</a:t>
            </a: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2719440" y="5156280"/>
            <a:ext cx="43056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108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3151080" y="5156280"/>
            <a:ext cx="43056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145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3641760" y="5156280"/>
            <a:ext cx="40752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4049640" y="5156280"/>
            <a:ext cx="43056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108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>
            <a:off x="4518000" y="5157720"/>
            <a:ext cx="43056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145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4973760" y="5156280"/>
            <a:ext cx="40752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5418000" y="5156280"/>
            <a:ext cx="43056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108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5850000" y="5157720"/>
            <a:ext cx="43056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145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6342120" y="5156280"/>
            <a:ext cx="407520" cy="2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3205440" y="5508720"/>
            <a:ext cx="415080" cy="45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1" lang="de-DE" sz="2700" spc="-1" strike="noStrike">
                <a:solidFill>
                  <a:srgbClr val="000000"/>
                </a:solidFill>
                <a:latin typeface="Arial"/>
              </a:rPr>
              <a:t>W</a:t>
            </a: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>
            <a:off x="4321800" y="5508720"/>
            <a:ext cx="861840" cy="45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1" lang="de-DE" sz="2700" spc="-1" strike="noStrike">
                <a:solidFill>
                  <a:srgbClr val="000000"/>
                </a:solidFill>
                <a:latin typeface="Arial"/>
              </a:rPr>
              <a:t>W+R</a:t>
            </a: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2738160" y="2867040"/>
            <a:ext cx="2689200" cy="41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cis-</a:t>
            </a:r>
            <a:r>
              <a:rPr b="0" lang="en-US" sz="24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-Bergamotene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3791160" y="396720"/>
            <a:ext cx="566280" cy="412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3040" bIns="23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25560"/>
                <a:tab algn="l" pos="1851120"/>
                <a:tab algn="l" pos="2776680"/>
                <a:tab algn="l" pos="3701880"/>
                <a:tab algn="l" pos="4627440"/>
                <a:tab algn="l" pos="5553000"/>
                <a:tab algn="l" pos="6478560"/>
                <a:tab algn="l" pos="7404120"/>
                <a:tab algn="l" pos="8329680"/>
                <a:tab algn="l" pos="9255240"/>
                <a:tab algn="l" pos="101808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TPI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3-10-24T08:00:56Z</dcterms:created>
  <dc:creator>Anke Steppuhn</dc:creator>
  <dc:description/>
  <dc:language>en-US</dc:language>
  <cp:lastModifiedBy>Anke Steppuhn</cp:lastModifiedBy>
  <dcterms:modified xsi:type="dcterms:W3CDTF">2004-05-01T11:48:16Z</dcterms:modified>
  <cp:revision>5</cp:revision>
  <dc:subject/>
  <dc:title>PowerPoint-Präsentation</dc:title>
</cp:coreProperties>
</file>